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696" y="88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314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7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83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435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16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265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686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940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807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148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04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855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9FD5D425-42F0-4B1C-A56D-C9FE63A7216F}"/>
              </a:ext>
            </a:extLst>
          </p:cNvPr>
          <p:cNvSpPr txBox="1"/>
          <p:nvPr/>
        </p:nvSpPr>
        <p:spPr>
          <a:xfrm>
            <a:off x="732711" y="96892"/>
            <a:ext cx="102705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abundance of phyla in all samples. Samples are grouped according to sample type (i.e. carcasses, faeces, caeca, surface_T1, and surface_T2</a:t>
            </a:r>
          </a:p>
        </p:txBody>
      </p:sp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F8254221-006F-48CD-8D80-FB3CB27A6C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0870041"/>
              </p:ext>
            </p:extLst>
          </p:nvPr>
        </p:nvGraphicFramePr>
        <p:xfrm>
          <a:off x="364109" y="845590"/>
          <a:ext cx="11463782" cy="51652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10" r:id="rId3" imgW="9473730" imgH="4269439" progId="Prism10.Document">
                  <p:embed/>
                </p:oleObj>
              </mc:Choice>
              <mc:Fallback>
                <p:oleObj name="Prism 10" r:id="rId3" imgW="9473730" imgH="426943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4109" y="845590"/>
                        <a:ext cx="11463782" cy="51652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734206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3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Prism 10</vt:lpstr>
      <vt:lpstr>Presentazione standard di PowerPoint</vt:lpstr>
    </vt:vector>
  </TitlesOfParts>
  <Company>Università degli Studi di Pado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coni Andrea</dc:creator>
  <cp:lastModifiedBy>Andrea Laconi</cp:lastModifiedBy>
  <cp:revision>16</cp:revision>
  <dcterms:created xsi:type="dcterms:W3CDTF">2022-03-15T12:01:40Z</dcterms:created>
  <dcterms:modified xsi:type="dcterms:W3CDTF">2025-04-17T12:58:10Z</dcterms:modified>
</cp:coreProperties>
</file>